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Styl pośredni 3 — Ak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75" autoAdjust="0"/>
    <p:restoredTop sz="94660"/>
  </p:normalViewPr>
  <p:slideViewPr>
    <p:cSldViewPr>
      <p:cViewPr varScale="1">
        <p:scale>
          <a:sx n="122" d="100"/>
          <a:sy n="122" d="100"/>
        </p:scale>
        <p:origin x="182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78436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5572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28721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56283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7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4595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85102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4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6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4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63481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63516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82547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96" indent="0">
              <a:buNone/>
              <a:defRPr sz="1200"/>
            </a:lvl2pPr>
            <a:lvl3pPr marL="914390" indent="0">
              <a:buNone/>
              <a:defRPr sz="1000"/>
            </a:lvl3pPr>
            <a:lvl4pPr marL="1371584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47737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96" indent="0">
              <a:buNone/>
              <a:defRPr sz="2800"/>
            </a:lvl2pPr>
            <a:lvl3pPr marL="914390" indent="0">
              <a:buNone/>
              <a:defRPr sz="2400"/>
            </a:lvl3pPr>
            <a:lvl4pPr marL="1371584" indent="0">
              <a:buNone/>
              <a:defRPr sz="2000"/>
            </a:lvl4pPr>
            <a:lvl5pPr marL="1828778" indent="0">
              <a:buNone/>
              <a:defRPr sz="2000"/>
            </a:lvl5pPr>
            <a:lvl6pPr marL="2285974" indent="0">
              <a:buNone/>
              <a:defRPr sz="2000"/>
            </a:lvl6pPr>
            <a:lvl7pPr marL="2743169" indent="0">
              <a:buNone/>
              <a:defRPr sz="2000"/>
            </a:lvl7pPr>
            <a:lvl8pPr marL="3200363" indent="0">
              <a:buNone/>
              <a:defRPr sz="2000"/>
            </a:lvl8pPr>
            <a:lvl9pPr marL="3657558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96" indent="0">
              <a:buNone/>
              <a:defRPr sz="1200"/>
            </a:lvl2pPr>
            <a:lvl3pPr marL="914390" indent="0">
              <a:buNone/>
              <a:defRPr sz="1000"/>
            </a:lvl3pPr>
            <a:lvl4pPr marL="1371584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89446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70481-53D3-4128-8E65-3D7B5E7E77B7}" type="datetimeFigureOut">
              <a:rPr lang="pl-PL" smtClean="0"/>
              <a:t>2020-09-16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E927F-41C6-4A8B-9DD0-643C495D8AF2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74388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9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6" indent="-3428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1" indent="-285747" algn="l" defTabSz="914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86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82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76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71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66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60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55" indent="-228596" algn="l" defTabSz="91439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6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0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4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78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74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69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63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58" algn="l" defTabSz="91439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555776" y="1628800"/>
            <a:ext cx="230425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indent="449258" fontAlgn="base">
              <a:spcBef>
                <a:spcPct val="0"/>
              </a:spcBef>
              <a:spcAft>
                <a:spcPct val="0"/>
              </a:spcAft>
            </a:pPr>
            <a:r>
              <a:rPr lang="en-US" altLang="pl-PL" sz="1600" b="1" dirty="0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Strat</a:t>
            </a:r>
            <a:r>
              <a:rPr lang="pl-PL" altLang="pl-PL" sz="1600" b="1" dirty="0" err="1" smtClean="0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ification</a:t>
            </a:r>
            <a:endParaRPr lang="pl-PL" altLang="pl-PL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e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46615"/>
              </p:ext>
            </p:extLst>
          </p:nvPr>
        </p:nvGraphicFramePr>
        <p:xfrm>
          <a:off x="2123728" y="2031524"/>
          <a:ext cx="4680520" cy="3893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9396"/>
                <a:gridCol w="1752972"/>
                <a:gridCol w="1368152"/>
              </a:tblGrid>
              <a:tr h="3893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pl-PL" sz="14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rm</a:t>
                      </a:r>
                      <a:r>
                        <a:rPr lang="pl-PL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4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</a:t>
                      </a:r>
                      <a:endParaRPr lang="pl-PL" sz="11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72000" marB="72000" anchor="ctr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</a:t>
                      </a: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pl-PL" sz="14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d</a:t>
                      </a:r>
                      <a:r>
                        <a:rPr lang="pl-PL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4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ase</a:t>
                      </a:r>
                      <a:endParaRPr lang="pl-PL" sz="14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72000" marB="72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4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s</a:t>
                      </a:r>
                      <a:endParaRPr lang="pl-PL" sz="11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72000" marB="72000" anchor="ctr">
                    <a:noFill/>
                  </a:tcPr>
                </a:tc>
              </a:tr>
            </a:tbl>
          </a:graphicData>
        </a:graphic>
      </p:graphicFrame>
      <p:graphicFrame>
        <p:nvGraphicFramePr>
          <p:cNvPr id="8" name="Tabe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2835382"/>
              </p:ext>
            </p:extLst>
          </p:nvPr>
        </p:nvGraphicFramePr>
        <p:xfrm>
          <a:off x="2123731" y="2636916"/>
          <a:ext cx="4680519" cy="20566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47806"/>
                <a:gridCol w="1784043"/>
                <a:gridCol w="1348670"/>
              </a:tblGrid>
              <a:tr h="84124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             </a:t>
                      </a:r>
                      <a:r>
                        <a:rPr lang="pl-PL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P2   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pl-PL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r>
                        <a:rPr lang="pl-PL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pl-PL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200" b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                       </a:t>
                      </a:r>
                      <a:r>
                        <a:rPr lang="pl-PL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</a:t>
                      </a:r>
                      <a:endParaRPr lang="pl-PL" sz="1200" b="1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pl-PL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pl-PL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l-PL" sz="1200" baseline="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l-PL" sz="1200" baseline="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200" b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           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</a:t>
                      </a:r>
                      <a:endParaRPr lang="pl-PL" sz="12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2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r>
                        <a:rPr lang="pl-PL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pl-PL" sz="12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84189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</a:t>
                      </a:r>
                      <a:r>
                        <a:rPr lang="pl-PL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s</a:t>
                      </a:r>
                      <a:endParaRPr lang="pl-PL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l-PL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pl-P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l-PL"/>
                    </a:p>
                  </a:txBody>
                  <a:tcPr/>
                </a:tc>
              </a:tr>
              <a:tr h="841248">
                <a:tc vMerge="1">
                  <a:txBody>
                    <a:bodyPr/>
                    <a:lstStyle/>
                    <a:p>
                      <a:endParaRPr lang="pl-P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l-P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</a:t>
                      </a:r>
                      <a:r>
                        <a:rPr lang="pl-PL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s</a:t>
                      </a:r>
                      <a:endParaRPr lang="pl-PL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pl-PL" sz="12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l-PL" sz="12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pl-PL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°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pl-PL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89962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pl-PL" sz="11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pl-PL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</a:t>
                      </a:r>
                      <a:r>
                        <a:rPr lang="pl-PL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s</a:t>
                      </a:r>
                      <a:endParaRPr lang="pl-PL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39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</a:t>
                      </a:r>
                      <a:r>
                        <a:rPr lang="pl-PL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s</a:t>
                      </a:r>
                      <a:r>
                        <a:rPr lang="pl-PL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l-PL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</a:tbl>
          </a:graphicData>
        </a:graphic>
      </p:graphicFrame>
      <p:sp>
        <p:nvSpPr>
          <p:cNvPr id="16" name="Elipsa 15"/>
          <p:cNvSpPr/>
          <p:nvPr/>
        </p:nvSpPr>
        <p:spPr>
          <a:xfrm>
            <a:off x="2123728" y="3275538"/>
            <a:ext cx="169177" cy="16439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Elipsa 17"/>
          <p:cNvSpPr/>
          <p:nvPr/>
        </p:nvSpPr>
        <p:spPr>
          <a:xfrm>
            <a:off x="5225311" y="4198097"/>
            <a:ext cx="180020" cy="16700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Elipsa 19"/>
          <p:cNvSpPr/>
          <p:nvPr/>
        </p:nvSpPr>
        <p:spPr>
          <a:xfrm>
            <a:off x="6588226" y="3340057"/>
            <a:ext cx="171566" cy="17932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Elipsa 20"/>
          <p:cNvSpPr/>
          <p:nvPr/>
        </p:nvSpPr>
        <p:spPr>
          <a:xfrm>
            <a:off x="3436502" y="3274485"/>
            <a:ext cx="169177" cy="164395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Prostokąt 1"/>
          <p:cNvSpPr/>
          <p:nvPr/>
        </p:nvSpPr>
        <p:spPr>
          <a:xfrm>
            <a:off x="1907704" y="1556792"/>
            <a:ext cx="5112568" cy="33562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76496" y="1628800"/>
            <a:ext cx="182775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indent="449258" fontAlgn="base">
              <a:spcBef>
                <a:spcPct val="0"/>
              </a:spcBef>
              <a:spcAft>
                <a:spcPct val="0"/>
              </a:spcAft>
            </a:pPr>
            <a:r>
              <a:rPr lang="pl-PL" altLang="pl-PL" sz="1600" b="1" dirty="0" err="1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G</a:t>
            </a:r>
            <a:r>
              <a:rPr lang="pl-PL" altLang="pl-PL" sz="1600" b="1" dirty="0" err="1" smtClean="0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ermination</a:t>
            </a:r>
            <a:endParaRPr lang="pl-PL" altLang="pl-PL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Prostokąt 3"/>
          <p:cNvSpPr/>
          <p:nvPr/>
        </p:nvSpPr>
        <p:spPr>
          <a:xfrm>
            <a:off x="1907704" y="5019823"/>
            <a:ext cx="511256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pl-PL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pl-PL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xperimental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design of </a:t>
            </a:r>
            <a:r>
              <a:rPr 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osa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anin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L. seed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ormanc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reaking by warm/cold stratification (16 weeks at 25°C followed by 22 weeks at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3°C)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nd g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rmination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ests </a:t>
            </a:r>
            <a:r>
              <a:rPr lang="pl-PL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8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eeks </a:t>
            </a:r>
            <a:r>
              <a:rPr lang="pl-PL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t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°C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0°C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1-4 </a:t>
            </a:r>
            <a:r>
              <a:rPr lang="pl-PL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erms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pl-PL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ample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pl-PL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llections</a:t>
            </a:r>
            <a:r>
              <a:rPr lang="pl-PL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3499570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Aerodynamiczny">
      <a:dk1>
        <a:sysClr val="windowText" lastClr="000000"/>
      </a:dk1>
      <a:lt1>
        <a:sysClr val="window" lastClr="FFFFFF"/>
      </a:lt1>
      <a:dk2>
        <a:srgbClr val="212745"/>
      </a:dk2>
      <a:lt2>
        <a:srgbClr val="B4DCFA"/>
      </a:lt2>
      <a:accent1>
        <a:srgbClr val="4E67C8"/>
      </a:accent1>
      <a:accent2>
        <a:srgbClr val="5ECCF3"/>
      </a:accent2>
      <a:accent3>
        <a:srgbClr val="A7EA52"/>
      </a:accent3>
      <a:accent4>
        <a:srgbClr val="5DCEAF"/>
      </a:accent4>
      <a:accent5>
        <a:srgbClr val="FF8021"/>
      </a:accent5>
      <a:accent6>
        <a:srgbClr val="F14124"/>
      </a:accent6>
      <a:hlink>
        <a:srgbClr val="56C7AA"/>
      </a:hlink>
      <a:folHlink>
        <a:srgbClr val="59A8D1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81</Words>
  <Application>Microsoft Office PowerPoint</Application>
  <PresentationFormat>Pokaz na ekranie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Motyw pakietu Office</vt:lpstr>
      <vt:lpstr>Prezentacja programu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mp</dc:creator>
  <cp:lastModifiedBy>TAP</cp:lastModifiedBy>
  <cp:revision>44</cp:revision>
  <dcterms:created xsi:type="dcterms:W3CDTF">2017-08-24T11:47:47Z</dcterms:created>
  <dcterms:modified xsi:type="dcterms:W3CDTF">2020-09-16T12:30:43Z</dcterms:modified>
</cp:coreProperties>
</file>